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3" r:id="rId4"/>
  </p:sldMasterIdLst>
  <p:notesMasterIdLst>
    <p:notesMasterId r:id="rId6"/>
  </p:notesMasterIdLst>
  <p:sldIdLst>
    <p:sldId id="325" r:id="rId5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2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am,Alda Lui" initials="TL" lastIdx="2" clrIdx="0">
    <p:extLst>
      <p:ext uri="{19B8F6BF-5375-455C-9EA6-DF929625EA0E}">
        <p15:presenceInfo xmlns:p15="http://schemas.microsoft.com/office/powerpoint/2012/main" userId="S-1-5-21-1567877469-3263605706-1227183214-2416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39BFF20-77C4-400C-9D42-822619122CFA}" v="21" dt="2020-05-26T21:11:40.904"/>
  </p1510:revLst>
</p1510:revInfo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364" autoAdjust="0"/>
    <p:restoredTop sz="94677"/>
  </p:normalViewPr>
  <p:slideViewPr>
    <p:cSldViewPr snapToGrid="0" snapToObjects="1" showGuides="1">
      <p:cViewPr varScale="1">
        <p:scale>
          <a:sx n="84" d="100"/>
          <a:sy n="84" d="100"/>
        </p:scale>
        <p:origin x="2875" y="55"/>
      </p:cViewPr>
      <p:guideLst>
        <p:guide orient="horz" pos="2832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24" Type="http://schemas.microsoft.com/office/2015/10/relationships/revisionInfo" Target="revisionInfo.xml"/><Relationship Id="rId5" Type="http://schemas.openxmlformats.org/officeDocument/2006/relationships/slide" Target="slides/slide1.xml"/><Relationship Id="rId23" Type="http://schemas.microsoft.com/office/2016/11/relationships/changesInfo" Target="changesInfos/changesInfo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masco,Jossana" userId="S::jdamasco@mdanderson.org::67c1be48-790c-45d4-876f-541e7acc6f9d" providerId="AD" clId="Web-{039BFF20-77C4-400C-9D42-822619122CFA}"/>
    <pc:docChg chg="modSld">
      <pc:chgData name="Damasco,Jossana" userId="S::jdamasco@mdanderson.org::67c1be48-790c-45d4-876f-541e7acc6f9d" providerId="AD" clId="Web-{039BFF20-77C4-400C-9D42-822619122CFA}" dt="2020-05-26T21:11:40.904" v="17" actId="1076"/>
      <pc:docMkLst>
        <pc:docMk/>
      </pc:docMkLst>
      <pc:sldChg chg="addSp delSp modSp">
        <pc:chgData name="Damasco,Jossana" userId="S::jdamasco@mdanderson.org::67c1be48-790c-45d4-876f-541e7acc6f9d" providerId="AD" clId="Web-{039BFF20-77C4-400C-9D42-822619122CFA}" dt="2020-05-26T21:11:40.904" v="17" actId="1076"/>
        <pc:sldMkLst>
          <pc:docMk/>
          <pc:sldMk cId="4270936402" sldId="300"/>
        </pc:sldMkLst>
        <pc:picChg chg="add del mod">
          <ac:chgData name="Damasco,Jossana" userId="S::jdamasco@mdanderson.org::67c1be48-790c-45d4-876f-541e7acc6f9d" providerId="AD" clId="Web-{039BFF20-77C4-400C-9D42-822619122CFA}" dt="2020-05-26T21:09:49.559" v="7"/>
          <ac:picMkLst>
            <pc:docMk/>
            <pc:sldMk cId="4270936402" sldId="300"/>
            <ac:picMk id="3" creationId="{F74ABE9A-FD27-40BB-AAC5-3F61B5E6AAF8}"/>
          </ac:picMkLst>
        </pc:picChg>
        <pc:picChg chg="add mod">
          <ac:chgData name="Damasco,Jossana" userId="S::jdamasco@mdanderson.org::67c1be48-790c-45d4-876f-541e7acc6f9d" providerId="AD" clId="Web-{039BFF20-77C4-400C-9D42-822619122CFA}" dt="2020-05-26T21:10:44.934" v="13" actId="1076"/>
          <ac:picMkLst>
            <pc:docMk/>
            <pc:sldMk cId="4270936402" sldId="300"/>
            <ac:picMk id="5" creationId="{D26A28B1-EF73-4F52-AF36-FC343EDD486B}"/>
          </ac:picMkLst>
        </pc:picChg>
        <pc:picChg chg="add mod">
          <ac:chgData name="Damasco,Jossana" userId="S::jdamasco@mdanderson.org::67c1be48-790c-45d4-876f-541e7acc6f9d" providerId="AD" clId="Web-{039BFF20-77C4-400C-9D42-822619122CFA}" dt="2020-05-26T21:11:40.904" v="17" actId="1076"/>
          <ac:picMkLst>
            <pc:docMk/>
            <pc:sldMk cId="4270936402" sldId="300"/>
            <ac:picMk id="6" creationId="{3DA3B2E1-4FD2-42FE-AF64-0CD5343C8EE0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2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9FA6030-4C35-9042-AD4B-73F9C8B6A4C6}" type="datetimeFigureOut">
              <a:rPr lang="en-US" smtClean="0"/>
              <a:t>1/1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4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D230F29C-1FAF-ED40-80E3-6453F54FA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2150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3" indent="0" algn="ctr">
              <a:buNone/>
              <a:defRPr sz="1500"/>
            </a:lvl2pPr>
            <a:lvl3pPr marL="685766" indent="0" algn="ctr">
              <a:buNone/>
              <a:defRPr sz="1351"/>
            </a:lvl3pPr>
            <a:lvl4pPr marL="1028649" indent="0" algn="ctr">
              <a:buNone/>
              <a:defRPr sz="1200"/>
            </a:lvl4pPr>
            <a:lvl5pPr marL="1371532" indent="0" algn="ctr">
              <a:buNone/>
              <a:defRPr sz="1200"/>
            </a:lvl5pPr>
            <a:lvl6pPr marL="1714414" indent="0" algn="ctr">
              <a:buNone/>
              <a:defRPr sz="1200"/>
            </a:lvl6pPr>
            <a:lvl7pPr marL="2057297" indent="0" algn="ctr">
              <a:buNone/>
              <a:defRPr sz="1200"/>
            </a:lvl7pPr>
            <a:lvl8pPr marL="2400180" indent="0" algn="ctr">
              <a:buNone/>
              <a:defRPr sz="1200"/>
            </a:lvl8pPr>
            <a:lvl9pPr marL="2743063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4297A-B5A1-7145-9DD5-3CE56BF727D8}" type="datetimeFigureOut">
              <a:rPr lang="en-US" smtClean="0"/>
              <a:t>1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FCAD8-7D9C-544B-BA35-41899B890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6589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4297A-B5A1-7145-9DD5-3CE56BF727D8}" type="datetimeFigureOut">
              <a:rPr lang="en-US" smtClean="0"/>
              <a:t>1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FCAD8-7D9C-544B-BA35-41899B890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5752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6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6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4297A-B5A1-7145-9DD5-3CE56BF727D8}" type="datetimeFigureOut">
              <a:rPr lang="en-US" smtClean="0"/>
              <a:t>1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FCAD8-7D9C-544B-BA35-41899B890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68682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3_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>
            <a:cxnSpLocks noChangeShapeType="1"/>
          </p:cNvCxnSpPr>
          <p:nvPr/>
        </p:nvCxnSpPr>
        <p:spPr bwMode="auto">
          <a:xfrm>
            <a:off x="211935" y="7785100"/>
            <a:ext cx="6396037" cy="10584"/>
          </a:xfrm>
          <a:prstGeom prst="line">
            <a:avLst/>
          </a:prstGeom>
          <a:noFill/>
          <a:ln w="25400">
            <a:solidFill>
              <a:srgbClr val="FF0000"/>
            </a:solidFill>
            <a:round/>
            <a:headEnd/>
            <a:tailEnd/>
          </a:ln>
          <a:effectLst>
            <a:outerShdw blurRad="635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511" y="952469"/>
            <a:ext cx="5829300" cy="470355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1pPr>
            <a:lvl2pPr marL="257167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2pPr>
            <a:lvl3pPr marL="51433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3pPr>
            <a:lvl4pPr marL="771497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4pPr>
            <a:lvl5pPr marL="1028661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5pPr>
            <a:lvl6pPr marL="1285828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6pPr>
            <a:lvl7pPr marL="1542992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7pPr>
            <a:lvl8pPr marL="1800158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8pPr>
            <a:lvl9pPr marL="2057323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pic>
        <p:nvPicPr>
          <p:cNvPr id="6" name="Picture 5" descr="MDAnderson Master Logo_Texas_V_Tagline_RGB.png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94749" y="8069956"/>
            <a:ext cx="1013222" cy="872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85287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4297A-B5A1-7145-9DD5-3CE56BF727D8}" type="datetimeFigureOut">
              <a:rPr lang="en-US" smtClean="0"/>
              <a:t>1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FCAD8-7D9C-544B-BA35-41899B890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439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279656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119289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3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66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4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3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9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8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6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4297A-B5A1-7145-9DD5-3CE56BF727D8}" type="datetimeFigureOut">
              <a:rPr lang="en-US" smtClean="0"/>
              <a:t>1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FCAD8-7D9C-544B-BA35-41899B890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8327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4297A-B5A1-7145-9DD5-3CE56BF727D8}" type="datetimeFigureOut">
              <a:rPr lang="en-US" smtClean="0"/>
              <a:t>1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FCAD8-7D9C-544B-BA35-41899B890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320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8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3" indent="0">
              <a:buNone/>
              <a:defRPr sz="1500" b="1"/>
            </a:lvl2pPr>
            <a:lvl3pPr marL="685766" indent="0">
              <a:buNone/>
              <a:defRPr sz="1351" b="1"/>
            </a:lvl3pPr>
            <a:lvl4pPr marL="1028649" indent="0">
              <a:buNone/>
              <a:defRPr sz="1200" b="1"/>
            </a:lvl4pPr>
            <a:lvl5pPr marL="1371532" indent="0">
              <a:buNone/>
              <a:defRPr sz="1200" b="1"/>
            </a:lvl5pPr>
            <a:lvl6pPr marL="1714414" indent="0">
              <a:buNone/>
              <a:defRPr sz="1200" b="1"/>
            </a:lvl6pPr>
            <a:lvl7pPr marL="2057297" indent="0">
              <a:buNone/>
              <a:defRPr sz="1200" b="1"/>
            </a:lvl7pPr>
            <a:lvl8pPr marL="2400180" indent="0">
              <a:buNone/>
              <a:defRPr sz="1200" b="1"/>
            </a:lvl8pPr>
            <a:lvl9pPr marL="2743063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5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3" indent="0">
              <a:buNone/>
              <a:defRPr sz="1500" b="1"/>
            </a:lvl2pPr>
            <a:lvl3pPr marL="685766" indent="0">
              <a:buNone/>
              <a:defRPr sz="1351" b="1"/>
            </a:lvl3pPr>
            <a:lvl4pPr marL="1028649" indent="0">
              <a:buNone/>
              <a:defRPr sz="1200" b="1"/>
            </a:lvl4pPr>
            <a:lvl5pPr marL="1371532" indent="0">
              <a:buNone/>
              <a:defRPr sz="1200" b="1"/>
            </a:lvl5pPr>
            <a:lvl6pPr marL="1714414" indent="0">
              <a:buNone/>
              <a:defRPr sz="1200" b="1"/>
            </a:lvl6pPr>
            <a:lvl7pPr marL="2057297" indent="0">
              <a:buNone/>
              <a:defRPr sz="1200" b="1"/>
            </a:lvl7pPr>
            <a:lvl8pPr marL="2400180" indent="0">
              <a:buNone/>
              <a:defRPr sz="1200" b="1"/>
            </a:lvl8pPr>
            <a:lvl9pPr marL="2743063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5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4297A-B5A1-7145-9DD5-3CE56BF727D8}" type="datetimeFigureOut">
              <a:rPr lang="en-US" smtClean="0"/>
              <a:t>1/1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FCAD8-7D9C-544B-BA35-41899B890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45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4297A-B5A1-7145-9DD5-3CE56BF727D8}" type="datetimeFigureOut">
              <a:rPr lang="en-US" smtClean="0"/>
              <a:t>1/1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FCAD8-7D9C-544B-BA35-41899B890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0135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4297A-B5A1-7145-9DD5-3CE56BF727D8}" type="datetimeFigureOut">
              <a:rPr lang="en-US" smtClean="0"/>
              <a:t>1/1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FCAD8-7D9C-544B-BA35-41899B890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053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316571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83" indent="0">
              <a:buNone/>
              <a:defRPr sz="1051"/>
            </a:lvl2pPr>
            <a:lvl3pPr marL="685766" indent="0">
              <a:buNone/>
              <a:defRPr sz="900"/>
            </a:lvl3pPr>
            <a:lvl4pPr marL="1028649" indent="0">
              <a:buNone/>
              <a:defRPr sz="751"/>
            </a:lvl4pPr>
            <a:lvl5pPr marL="1371532" indent="0">
              <a:buNone/>
              <a:defRPr sz="751"/>
            </a:lvl5pPr>
            <a:lvl6pPr marL="1714414" indent="0">
              <a:buNone/>
              <a:defRPr sz="751"/>
            </a:lvl6pPr>
            <a:lvl7pPr marL="2057297" indent="0">
              <a:buNone/>
              <a:defRPr sz="751"/>
            </a:lvl7pPr>
            <a:lvl8pPr marL="2400180" indent="0">
              <a:buNone/>
              <a:defRPr sz="751"/>
            </a:lvl8pPr>
            <a:lvl9pPr marL="2743063" indent="0">
              <a:buNone/>
              <a:defRPr sz="75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4297A-B5A1-7145-9DD5-3CE56BF727D8}" type="datetimeFigureOut">
              <a:rPr lang="en-US" smtClean="0"/>
              <a:t>1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FCAD8-7D9C-544B-BA35-41899B890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02489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316571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3" indent="0">
              <a:buNone/>
              <a:defRPr sz="2100"/>
            </a:lvl2pPr>
            <a:lvl3pPr marL="685766" indent="0">
              <a:buNone/>
              <a:defRPr sz="1800"/>
            </a:lvl3pPr>
            <a:lvl4pPr marL="1028649" indent="0">
              <a:buNone/>
              <a:defRPr sz="1500"/>
            </a:lvl4pPr>
            <a:lvl5pPr marL="1371532" indent="0">
              <a:buNone/>
              <a:defRPr sz="1500"/>
            </a:lvl5pPr>
            <a:lvl6pPr marL="1714414" indent="0">
              <a:buNone/>
              <a:defRPr sz="1500"/>
            </a:lvl6pPr>
            <a:lvl7pPr marL="2057297" indent="0">
              <a:buNone/>
              <a:defRPr sz="1500"/>
            </a:lvl7pPr>
            <a:lvl8pPr marL="2400180" indent="0">
              <a:buNone/>
              <a:defRPr sz="1500"/>
            </a:lvl8pPr>
            <a:lvl9pPr marL="2743063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83" indent="0">
              <a:buNone/>
              <a:defRPr sz="1051"/>
            </a:lvl2pPr>
            <a:lvl3pPr marL="685766" indent="0">
              <a:buNone/>
              <a:defRPr sz="900"/>
            </a:lvl3pPr>
            <a:lvl4pPr marL="1028649" indent="0">
              <a:buNone/>
              <a:defRPr sz="751"/>
            </a:lvl4pPr>
            <a:lvl5pPr marL="1371532" indent="0">
              <a:buNone/>
              <a:defRPr sz="751"/>
            </a:lvl5pPr>
            <a:lvl6pPr marL="1714414" indent="0">
              <a:buNone/>
              <a:defRPr sz="751"/>
            </a:lvl6pPr>
            <a:lvl7pPr marL="2057297" indent="0">
              <a:buNone/>
              <a:defRPr sz="751"/>
            </a:lvl7pPr>
            <a:lvl8pPr marL="2400180" indent="0">
              <a:buNone/>
              <a:defRPr sz="751"/>
            </a:lvl8pPr>
            <a:lvl9pPr marL="2743063" indent="0">
              <a:buNone/>
              <a:defRPr sz="75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4297A-B5A1-7145-9DD5-3CE56BF727D8}" type="datetimeFigureOut">
              <a:rPr lang="en-US" smtClean="0"/>
              <a:t>1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FCAD8-7D9C-544B-BA35-41899B890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2379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8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74297A-B5A1-7145-9DD5-3CE56BF727D8}" type="datetimeFigureOut">
              <a:rPr lang="en-US" smtClean="0"/>
              <a:t>1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8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6FCAD8-7D9C-544B-BA35-41899B890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4848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4" r:id="rId1"/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60" r:id="rId12"/>
  </p:sldLayoutIdLst>
  <p:txStyles>
    <p:titleStyle>
      <a:lvl1pPr algn="l" defTabSz="685766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2" indent="-171442" algn="l" defTabSz="685766" rtl="0" eaLnBrk="1" latinLnBrk="0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4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07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90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73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56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39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22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04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66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3" algn="l" defTabSz="685766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66" algn="l" defTabSz="685766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49" algn="l" defTabSz="685766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32" algn="l" defTabSz="685766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14" algn="l" defTabSz="685766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297" algn="l" defTabSz="685766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180" algn="l" defTabSz="685766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63" algn="l" defTabSz="685766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oup 27"/>
          <p:cNvGrpSpPr/>
          <p:nvPr/>
        </p:nvGrpSpPr>
        <p:grpSpPr>
          <a:xfrm>
            <a:off x="229808" y="1263237"/>
            <a:ext cx="4749634" cy="4342398"/>
            <a:chOff x="229808" y="1263237"/>
            <a:chExt cx="4749634" cy="4342398"/>
          </a:xfrm>
        </p:grpSpPr>
        <p:grpSp>
          <p:nvGrpSpPr>
            <p:cNvPr id="2" name="Group 1"/>
            <p:cNvGrpSpPr/>
            <p:nvPr/>
          </p:nvGrpSpPr>
          <p:grpSpPr>
            <a:xfrm>
              <a:off x="347430" y="1263237"/>
              <a:ext cx="4632012" cy="2458090"/>
              <a:chOff x="2558368" y="1189566"/>
              <a:chExt cx="4632012" cy="2458090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2558368" y="1263237"/>
                <a:ext cx="2766315" cy="2363925"/>
                <a:chOff x="550429" y="889807"/>
                <a:chExt cx="2683065" cy="2208994"/>
              </a:xfrm>
            </p:grpSpPr>
            <p:pic>
              <p:nvPicPr>
                <p:cNvPr id="24" name="Picture 23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38252"/>
                <a:stretch/>
              </p:blipFill>
              <p:spPr>
                <a:xfrm>
                  <a:off x="550429" y="889807"/>
                  <a:ext cx="2683065" cy="2208994"/>
                </a:xfrm>
                <a:prstGeom prst="rect">
                  <a:avLst/>
                </a:prstGeom>
              </p:spPr>
            </p:pic>
            <p:sp>
              <p:nvSpPr>
                <p:cNvPr id="25" name="Freeform 24"/>
                <p:cNvSpPr/>
                <p:nvPr/>
              </p:nvSpPr>
              <p:spPr>
                <a:xfrm>
                  <a:off x="908019" y="1768990"/>
                  <a:ext cx="1063930" cy="810047"/>
                </a:xfrm>
                <a:custGeom>
                  <a:avLst/>
                  <a:gdLst>
                    <a:gd name="connsiteX0" fmla="*/ 263556 w 1463706"/>
                    <a:gd name="connsiteY0" fmla="*/ 1038225 h 1114425"/>
                    <a:gd name="connsiteX1" fmla="*/ 330231 w 1463706"/>
                    <a:gd name="connsiteY1" fmla="*/ 1047750 h 1114425"/>
                    <a:gd name="connsiteX2" fmla="*/ 520731 w 1463706"/>
                    <a:gd name="connsiteY2" fmla="*/ 1076325 h 1114425"/>
                    <a:gd name="connsiteX3" fmla="*/ 558831 w 1463706"/>
                    <a:gd name="connsiteY3" fmla="*/ 1085850 h 1114425"/>
                    <a:gd name="connsiteX4" fmla="*/ 587406 w 1463706"/>
                    <a:gd name="connsiteY4" fmla="*/ 1095375 h 1114425"/>
                    <a:gd name="connsiteX5" fmla="*/ 663606 w 1463706"/>
                    <a:gd name="connsiteY5" fmla="*/ 1114425 h 1114425"/>
                    <a:gd name="connsiteX6" fmla="*/ 701706 w 1463706"/>
                    <a:gd name="connsiteY6" fmla="*/ 1104900 h 1114425"/>
                    <a:gd name="connsiteX7" fmla="*/ 796956 w 1463706"/>
                    <a:gd name="connsiteY7" fmla="*/ 1095375 h 1114425"/>
                    <a:gd name="connsiteX8" fmla="*/ 854106 w 1463706"/>
                    <a:gd name="connsiteY8" fmla="*/ 1076325 h 1114425"/>
                    <a:gd name="connsiteX9" fmla="*/ 892206 w 1463706"/>
                    <a:gd name="connsiteY9" fmla="*/ 1066800 h 1114425"/>
                    <a:gd name="connsiteX10" fmla="*/ 930306 w 1463706"/>
                    <a:gd name="connsiteY10" fmla="*/ 1047750 h 1114425"/>
                    <a:gd name="connsiteX11" fmla="*/ 1006506 w 1463706"/>
                    <a:gd name="connsiteY11" fmla="*/ 1028700 h 1114425"/>
                    <a:gd name="connsiteX12" fmla="*/ 1054131 w 1463706"/>
                    <a:gd name="connsiteY12" fmla="*/ 1000125 h 1114425"/>
                    <a:gd name="connsiteX13" fmla="*/ 1120806 w 1463706"/>
                    <a:gd name="connsiteY13" fmla="*/ 971550 h 1114425"/>
                    <a:gd name="connsiteX14" fmla="*/ 1177956 w 1463706"/>
                    <a:gd name="connsiteY14" fmla="*/ 933450 h 1114425"/>
                    <a:gd name="connsiteX15" fmla="*/ 1206531 w 1463706"/>
                    <a:gd name="connsiteY15" fmla="*/ 914400 h 1114425"/>
                    <a:gd name="connsiteX16" fmla="*/ 1263681 w 1463706"/>
                    <a:gd name="connsiteY16" fmla="*/ 857250 h 1114425"/>
                    <a:gd name="connsiteX17" fmla="*/ 1301781 w 1463706"/>
                    <a:gd name="connsiteY17" fmla="*/ 809625 h 1114425"/>
                    <a:gd name="connsiteX18" fmla="*/ 1320831 w 1463706"/>
                    <a:gd name="connsiteY18" fmla="*/ 781050 h 1114425"/>
                    <a:gd name="connsiteX19" fmla="*/ 1377981 w 1463706"/>
                    <a:gd name="connsiteY19" fmla="*/ 704850 h 1114425"/>
                    <a:gd name="connsiteX20" fmla="*/ 1397031 w 1463706"/>
                    <a:gd name="connsiteY20" fmla="*/ 666750 h 1114425"/>
                    <a:gd name="connsiteX21" fmla="*/ 1425606 w 1463706"/>
                    <a:gd name="connsiteY21" fmla="*/ 561975 h 1114425"/>
                    <a:gd name="connsiteX22" fmla="*/ 1454181 w 1463706"/>
                    <a:gd name="connsiteY22" fmla="*/ 457200 h 1114425"/>
                    <a:gd name="connsiteX23" fmla="*/ 1463706 w 1463706"/>
                    <a:gd name="connsiteY23" fmla="*/ 304800 h 1114425"/>
                    <a:gd name="connsiteX24" fmla="*/ 1444656 w 1463706"/>
                    <a:gd name="connsiteY24" fmla="*/ 142875 h 1114425"/>
                    <a:gd name="connsiteX25" fmla="*/ 1435131 w 1463706"/>
                    <a:gd name="connsiteY25" fmla="*/ 104775 h 1114425"/>
                    <a:gd name="connsiteX26" fmla="*/ 1425606 w 1463706"/>
                    <a:gd name="connsiteY26" fmla="*/ 57150 h 1114425"/>
                    <a:gd name="connsiteX27" fmla="*/ 1397031 w 1463706"/>
                    <a:gd name="connsiteY27" fmla="*/ 38100 h 1114425"/>
                    <a:gd name="connsiteX28" fmla="*/ 1301781 w 1463706"/>
                    <a:gd name="connsiteY28" fmla="*/ 0 h 1114425"/>
                    <a:gd name="connsiteX29" fmla="*/ 1282731 w 1463706"/>
                    <a:gd name="connsiteY29" fmla="*/ 28575 h 1114425"/>
                    <a:gd name="connsiteX30" fmla="*/ 1216056 w 1463706"/>
                    <a:gd name="connsiteY30" fmla="*/ 76200 h 1114425"/>
                    <a:gd name="connsiteX31" fmla="*/ 1149381 w 1463706"/>
                    <a:gd name="connsiteY31" fmla="*/ 104775 h 1114425"/>
                    <a:gd name="connsiteX32" fmla="*/ 1120806 w 1463706"/>
                    <a:gd name="connsiteY32" fmla="*/ 123825 h 1114425"/>
                    <a:gd name="connsiteX33" fmla="*/ 1054131 w 1463706"/>
                    <a:gd name="connsiteY33" fmla="*/ 152400 h 1114425"/>
                    <a:gd name="connsiteX34" fmla="*/ 882681 w 1463706"/>
                    <a:gd name="connsiteY34" fmla="*/ 257175 h 1114425"/>
                    <a:gd name="connsiteX35" fmla="*/ 844581 w 1463706"/>
                    <a:gd name="connsiteY35" fmla="*/ 285750 h 1114425"/>
                    <a:gd name="connsiteX36" fmla="*/ 787431 w 1463706"/>
                    <a:gd name="connsiteY36" fmla="*/ 314325 h 1114425"/>
                    <a:gd name="connsiteX37" fmla="*/ 739806 w 1463706"/>
                    <a:gd name="connsiteY37" fmla="*/ 342900 h 1114425"/>
                    <a:gd name="connsiteX38" fmla="*/ 682656 w 1463706"/>
                    <a:gd name="connsiteY38" fmla="*/ 361950 h 1114425"/>
                    <a:gd name="connsiteX39" fmla="*/ 615981 w 1463706"/>
                    <a:gd name="connsiteY39" fmla="*/ 400050 h 1114425"/>
                    <a:gd name="connsiteX40" fmla="*/ 520731 w 1463706"/>
                    <a:gd name="connsiteY40" fmla="*/ 447675 h 1114425"/>
                    <a:gd name="connsiteX41" fmla="*/ 482631 w 1463706"/>
                    <a:gd name="connsiteY41" fmla="*/ 466725 h 1114425"/>
                    <a:gd name="connsiteX42" fmla="*/ 396906 w 1463706"/>
                    <a:gd name="connsiteY42" fmla="*/ 523875 h 1114425"/>
                    <a:gd name="connsiteX43" fmla="*/ 358806 w 1463706"/>
                    <a:gd name="connsiteY43" fmla="*/ 552450 h 1114425"/>
                    <a:gd name="connsiteX44" fmla="*/ 234981 w 1463706"/>
                    <a:gd name="connsiteY44" fmla="*/ 638175 h 1114425"/>
                    <a:gd name="connsiteX45" fmla="*/ 196881 w 1463706"/>
                    <a:gd name="connsiteY45" fmla="*/ 666750 h 1114425"/>
                    <a:gd name="connsiteX46" fmla="*/ 168306 w 1463706"/>
                    <a:gd name="connsiteY46" fmla="*/ 695325 h 1114425"/>
                    <a:gd name="connsiteX47" fmla="*/ 139731 w 1463706"/>
                    <a:gd name="connsiteY47" fmla="*/ 714375 h 1114425"/>
                    <a:gd name="connsiteX48" fmla="*/ 82581 w 1463706"/>
                    <a:gd name="connsiteY48" fmla="*/ 819150 h 1114425"/>
                    <a:gd name="connsiteX49" fmla="*/ 54006 w 1463706"/>
                    <a:gd name="connsiteY49" fmla="*/ 876300 h 1114425"/>
                    <a:gd name="connsiteX50" fmla="*/ 25431 w 1463706"/>
                    <a:gd name="connsiteY50" fmla="*/ 962025 h 1114425"/>
                    <a:gd name="connsiteX51" fmla="*/ 6381 w 1463706"/>
                    <a:gd name="connsiteY51" fmla="*/ 1019175 h 1114425"/>
                    <a:gd name="connsiteX52" fmla="*/ 92106 w 1463706"/>
                    <a:gd name="connsiteY52" fmla="*/ 1009650 h 1114425"/>
                    <a:gd name="connsiteX53" fmla="*/ 139731 w 1463706"/>
                    <a:gd name="connsiteY53" fmla="*/ 1019175 h 1114425"/>
                    <a:gd name="connsiteX54" fmla="*/ 234981 w 1463706"/>
                    <a:gd name="connsiteY54" fmla="*/ 1047750 h 1114425"/>
                    <a:gd name="connsiteX55" fmla="*/ 263556 w 1463706"/>
                    <a:gd name="connsiteY55" fmla="*/ 1038225 h 11144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</a:cxnLst>
                  <a:rect l="l" t="t" r="r" b="b"/>
                  <a:pathLst>
                    <a:path w="1463706" h="1114425">
                      <a:moveTo>
                        <a:pt x="263556" y="1038225"/>
                      </a:moveTo>
                      <a:cubicBezTo>
                        <a:pt x="279431" y="1038225"/>
                        <a:pt x="307934" y="1045127"/>
                        <a:pt x="330231" y="1047750"/>
                      </a:cubicBezTo>
                      <a:cubicBezTo>
                        <a:pt x="427586" y="1059204"/>
                        <a:pt x="424749" y="1052330"/>
                        <a:pt x="520731" y="1076325"/>
                      </a:cubicBezTo>
                      <a:cubicBezTo>
                        <a:pt x="533431" y="1079500"/>
                        <a:pt x="546244" y="1082254"/>
                        <a:pt x="558831" y="1085850"/>
                      </a:cubicBezTo>
                      <a:cubicBezTo>
                        <a:pt x="568485" y="1088608"/>
                        <a:pt x="577720" y="1092733"/>
                        <a:pt x="587406" y="1095375"/>
                      </a:cubicBezTo>
                      <a:cubicBezTo>
                        <a:pt x="612665" y="1102264"/>
                        <a:pt x="663606" y="1114425"/>
                        <a:pt x="663606" y="1114425"/>
                      </a:cubicBezTo>
                      <a:cubicBezTo>
                        <a:pt x="676306" y="1111250"/>
                        <a:pt x="688747" y="1106751"/>
                        <a:pt x="701706" y="1104900"/>
                      </a:cubicBezTo>
                      <a:cubicBezTo>
                        <a:pt x="733294" y="1100387"/>
                        <a:pt x="765594" y="1101255"/>
                        <a:pt x="796956" y="1095375"/>
                      </a:cubicBezTo>
                      <a:cubicBezTo>
                        <a:pt x="816693" y="1091674"/>
                        <a:pt x="834625" y="1081195"/>
                        <a:pt x="854106" y="1076325"/>
                      </a:cubicBezTo>
                      <a:cubicBezTo>
                        <a:pt x="866806" y="1073150"/>
                        <a:pt x="879949" y="1071397"/>
                        <a:pt x="892206" y="1066800"/>
                      </a:cubicBezTo>
                      <a:cubicBezTo>
                        <a:pt x="905501" y="1061814"/>
                        <a:pt x="917255" y="1053343"/>
                        <a:pt x="930306" y="1047750"/>
                      </a:cubicBezTo>
                      <a:cubicBezTo>
                        <a:pt x="955934" y="1036767"/>
                        <a:pt x="978553" y="1034291"/>
                        <a:pt x="1006506" y="1028700"/>
                      </a:cubicBezTo>
                      <a:cubicBezTo>
                        <a:pt x="1022381" y="1019175"/>
                        <a:pt x="1037572" y="1008404"/>
                        <a:pt x="1054131" y="1000125"/>
                      </a:cubicBezTo>
                      <a:cubicBezTo>
                        <a:pt x="1132961" y="960710"/>
                        <a:pt x="1021704" y="1031011"/>
                        <a:pt x="1120806" y="971550"/>
                      </a:cubicBezTo>
                      <a:cubicBezTo>
                        <a:pt x="1140439" y="959770"/>
                        <a:pt x="1158906" y="946150"/>
                        <a:pt x="1177956" y="933450"/>
                      </a:cubicBezTo>
                      <a:cubicBezTo>
                        <a:pt x="1187481" y="927100"/>
                        <a:pt x="1198436" y="922495"/>
                        <a:pt x="1206531" y="914400"/>
                      </a:cubicBezTo>
                      <a:lnTo>
                        <a:pt x="1263681" y="857250"/>
                      </a:lnTo>
                      <a:cubicBezTo>
                        <a:pt x="1282224" y="801620"/>
                        <a:pt x="1258697" y="852709"/>
                        <a:pt x="1301781" y="809625"/>
                      </a:cubicBezTo>
                      <a:cubicBezTo>
                        <a:pt x="1309876" y="801530"/>
                        <a:pt x="1314098" y="790308"/>
                        <a:pt x="1320831" y="781050"/>
                      </a:cubicBezTo>
                      <a:cubicBezTo>
                        <a:pt x="1339505" y="755373"/>
                        <a:pt x="1363782" y="733248"/>
                        <a:pt x="1377981" y="704850"/>
                      </a:cubicBezTo>
                      <a:cubicBezTo>
                        <a:pt x="1384331" y="692150"/>
                        <a:pt x="1391438" y="679801"/>
                        <a:pt x="1397031" y="666750"/>
                      </a:cubicBezTo>
                      <a:cubicBezTo>
                        <a:pt x="1407714" y="641824"/>
                        <a:pt x="1422692" y="573630"/>
                        <a:pt x="1425606" y="561975"/>
                      </a:cubicBezTo>
                      <a:cubicBezTo>
                        <a:pt x="1440737" y="501451"/>
                        <a:pt x="1431535" y="536462"/>
                        <a:pt x="1454181" y="457200"/>
                      </a:cubicBezTo>
                      <a:cubicBezTo>
                        <a:pt x="1457356" y="406400"/>
                        <a:pt x="1463706" y="355699"/>
                        <a:pt x="1463706" y="304800"/>
                      </a:cubicBezTo>
                      <a:cubicBezTo>
                        <a:pt x="1463706" y="297152"/>
                        <a:pt x="1446750" y="155439"/>
                        <a:pt x="1444656" y="142875"/>
                      </a:cubicBezTo>
                      <a:cubicBezTo>
                        <a:pt x="1442504" y="129962"/>
                        <a:pt x="1437971" y="117554"/>
                        <a:pt x="1435131" y="104775"/>
                      </a:cubicBezTo>
                      <a:cubicBezTo>
                        <a:pt x="1431619" y="88971"/>
                        <a:pt x="1433638" y="71206"/>
                        <a:pt x="1425606" y="57150"/>
                      </a:cubicBezTo>
                      <a:cubicBezTo>
                        <a:pt x="1419926" y="47211"/>
                        <a:pt x="1406346" y="44754"/>
                        <a:pt x="1397031" y="38100"/>
                      </a:cubicBezTo>
                      <a:cubicBezTo>
                        <a:pt x="1339988" y="-2645"/>
                        <a:pt x="1378839" y="12843"/>
                        <a:pt x="1301781" y="0"/>
                      </a:cubicBezTo>
                      <a:cubicBezTo>
                        <a:pt x="1295431" y="9525"/>
                        <a:pt x="1290826" y="20480"/>
                        <a:pt x="1282731" y="28575"/>
                      </a:cubicBezTo>
                      <a:cubicBezTo>
                        <a:pt x="1278417" y="32889"/>
                        <a:pt x="1226873" y="70792"/>
                        <a:pt x="1216056" y="76200"/>
                      </a:cubicBezTo>
                      <a:cubicBezTo>
                        <a:pt x="1194429" y="87014"/>
                        <a:pt x="1171008" y="93961"/>
                        <a:pt x="1149381" y="104775"/>
                      </a:cubicBezTo>
                      <a:cubicBezTo>
                        <a:pt x="1139142" y="109895"/>
                        <a:pt x="1131045" y="118705"/>
                        <a:pt x="1120806" y="123825"/>
                      </a:cubicBezTo>
                      <a:cubicBezTo>
                        <a:pt x="1099179" y="134639"/>
                        <a:pt x="1075228" y="140586"/>
                        <a:pt x="1054131" y="152400"/>
                      </a:cubicBezTo>
                      <a:cubicBezTo>
                        <a:pt x="995693" y="185125"/>
                        <a:pt x="936262" y="216989"/>
                        <a:pt x="882681" y="257175"/>
                      </a:cubicBezTo>
                      <a:cubicBezTo>
                        <a:pt x="869981" y="266700"/>
                        <a:pt x="858194" y="277582"/>
                        <a:pt x="844581" y="285750"/>
                      </a:cubicBezTo>
                      <a:cubicBezTo>
                        <a:pt x="826318" y="296708"/>
                        <a:pt x="806129" y="304126"/>
                        <a:pt x="787431" y="314325"/>
                      </a:cubicBezTo>
                      <a:cubicBezTo>
                        <a:pt x="771178" y="323190"/>
                        <a:pt x="756660" y="335239"/>
                        <a:pt x="739806" y="342900"/>
                      </a:cubicBezTo>
                      <a:cubicBezTo>
                        <a:pt x="721525" y="351209"/>
                        <a:pt x="701300" y="354492"/>
                        <a:pt x="682656" y="361950"/>
                      </a:cubicBezTo>
                      <a:cubicBezTo>
                        <a:pt x="622843" y="385875"/>
                        <a:pt x="665621" y="373321"/>
                        <a:pt x="615981" y="400050"/>
                      </a:cubicBezTo>
                      <a:cubicBezTo>
                        <a:pt x="584726" y="416879"/>
                        <a:pt x="552481" y="431800"/>
                        <a:pt x="520731" y="447675"/>
                      </a:cubicBezTo>
                      <a:cubicBezTo>
                        <a:pt x="508031" y="454025"/>
                        <a:pt x="493990" y="458206"/>
                        <a:pt x="482631" y="466725"/>
                      </a:cubicBezTo>
                      <a:cubicBezTo>
                        <a:pt x="387712" y="537915"/>
                        <a:pt x="507134" y="450390"/>
                        <a:pt x="396906" y="523875"/>
                      </a:cubicBezTo>
                      <a:cubicBezTo>
                        <a:pt x="383697" y="532681"/>
                        <a:pt x="372015" y="543644"/>
                        <a:pt x="358806" y="552450"/>
                      </a:cubicBezTo>
                      <a:cubicBezTo>
                        <a:pt x="224075" y="642270"/>
                        <a:pt x="428686" y="492897"/>
                        <a:pt x="234981" y="638175"/>
                      </a:cubicBezTo>
                      <a:cubicBezTo>
                        <a:pt x="222281" y="647700"/>
                        <a:pt x="208106" y="655525"/>
                        <a:pt x="196881" y="666750"/>
                      </a:cubicBezTo>
                      <a:cubicBezTo>
                        <a:pt x="187356" y="676275"/>
                        <a:pt x="178654" y="686701"/>
                        <a:pt x="168306" y="695325"/>
                      </a:cubicBezTo>
                      <a:cubicBezTo>
                        <a:pt x="159512" y="702654"/>
                        <a:pt x="147826" y="706280"/>
                        <a:pt x="139731" y="714375"/>
                      </a:cubicBezTo>
                      <a:cubicBezTo>
                        <a:pt x="105691" y="748415"/>
                        <a:pt x="103636" y="773531"/>
                        <a:pt x="82581" y="819150"/>
                      </a:cubicBezTo>
                      <a:cubicBezTo>
                        <a:pt x="73656" y="838488"/>
                        <a:pt x="61916" y="856525"/>
                        <a:pt x="54006" y="876300"/>
                      </a:cubicBezTo>
                      <a:cubicBezTo>
                        <a:pt x="42819" y="904266"/>
                        <a:pt x="34956" y="933450"/>
                        <a:pt x="25431" y="962025"/>
                      </a:cubicBezTo>
                      <a:cubicBezTo>
                        <a:pt x="19081" y="981075"/>
                        <a:pt x="-13577" y="1021393"/>
                        <a:pt x="6381" y="1019175"/>
                      </a:cubicBezTo>
                      <a:lnTo>
                        <a:pt x="92106" y="1009650"/>
                      </a:lnTo>
                      <a:lnTo>
                        <a:pt x="139731" y="1019175"/>
                      </a:lnTo>
                      <a:cubicBezTo>
                        <a:pt x="187220" y="1027809"/>
                        <a:pt x="197007" y="1022434"/>
                        <a:pt x="234981" y="1047750"/>
                      </a:cubicBezTo>
                      <a:cubicBezTo>
                        <a:pt x="242453" y="1052731"/>
                        <a:pt x="247681" y="1038225"/>
                        <a:pt x="263556" y="1038225"/>
                      </a:cubicBezTo>
                      <a:close/>
                    </a:path>
                  </a:pathLst>
                </a:custGeom>
                <a:noFill/>
                <a:ln w="28575">
                  <a:solidFill>
                    <a:srgbClr val="00B050"/>
                  </a:solidFill>
                  <a:prstDash val="sys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1058677" y="2056457"/>
                  <a:ext cx="97385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solidFill>
                        <a:srgbClr val="00B050"/>
                      </a:solidFill>
                    </a:rPr>
                    <a:t>Normal </a:t>
                  </a:r>
                </a:p>
              </p:txBody>
            </p:sp>
          </p:grpSp>
          <p:grpSp>
            <p:nvGrpSpPr>
              <p:cNvPr id="4" name="Group 3"/>
              <p:cNvGrpSpPr/>
              <p:nvPr/>
            </p:nvGrpSpPr>
            <p:grpSpPr>
              <a:xfrm>
                <a:off x="5364970" y="1263237"/>
                <a:ext cx="1615115" cy="2384419"/>
                <a:chOff x="4725080" y="1880302"/>
                <a:chExt cx="1010920" cy="1432560"/>
              </a:xfrm>
            </p:grpSpPr>
            <p:pic>
              <p:nvPicPr>
                <p:cNvPr id="19" name="Picture 18"/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1833" t="27074" r="46683" b="32333"/>
                <a:stretch/>
              </p:blipFill>
              <p:spPr>
                <a:xfrm>
                  <a:off x="4725080" y="1880302"/>
                  <a:ext cx="1010920" cy="1432560"/>
                </a:xfrm>
                <a:prstGeom prst="rect">
                  <a:avLst/>
                </a:prstGeom>
              </p:spPr>
            </p:pic>
            <p:sp>
              <p:nvSpPr>
                <p:cNvPr id="20" name="Freeform 19"/>
                <p:cNvSpPr/>
                <p:nvPr/>
              </p:nvSpPr>
              <p:spPr>
                <a:xfrm>
                  <a:off x="4953808" y="2250195"/>
                  <a:ext cx="337182" cy="293158"/>
                </a:xfrm>
                <a:custGeom>
                  <a:avLst/>
                  <a:gdLst>
                    <a:gd name="connsiteX0" fmla="*/ 526842 w 534527"/>
                    <a:gd name="connsiteY0" fmla="*/ 418289 h 418820"/>
                    <a:gd name="connsiteX1" fmla="*/ 468476 w 534527"/>
                    <a:gd name="connsiteY1" fmla="*/ 379379 h 418820"/>
                    <a:gd name="connsiteX2" fmla="*/ 449021 w 534527"/>
                    <a:gd name="connsiteY2" fmla="*/ 359923 h 418820"/>
                    <a:gd name="connsiteX3" fmla="*/ 303106 w 534527"/>
                    <a:gd name="connsiteY3" fmla="*/ 330740 h 418820"/>
                    <a:gd name="connsiteX4" fmla="*/ 244740 w 534527"/>
                    <a:gd name="connsiteY4" fmla="*/ 321013 h 418820"/>
                    <a:gd name="connsiteX5" fmla="*/ 50187 w 534527"/>
                    <a:gd name="connsiteY5" fmla="*/ 340468 h 418820"/>
                    <a:gd name="connsiteX6" fmla="*/ 21004 w 534527"/>
                    <a:gd name="connsiteY6" fmla="*/ 350196 h 418820"/>
                    <a:gd name="connsiteX7" fmla="*/ 1548 w 534527"/>
                    <a:gd name="connsiteY7" fmla="*/ 369651 h 418820"/>
                    <a:gd name="connsiteX8" fmla="*/ 11276 w 534527"/>
                    <a:gd name="connsiteY8" fmla="*/ 330740 h 418820"/>
                    <a:gd name="connsiteX9" fmla="*/ 30731 w 534527"/>
                    <a:gd name="connsiteY9" fmla="*/ 204281 h 418820"/>
                    <a:gd name="connsiteX10" fmla="*/ 21004 w 534527"/>
                    <a:gd name="connsiteY10" fmla="*/ 38911 h 418820"/>
                    <a:gd name="connsiteX11" fmla="*/ 79370 w 534527"/>
                    <a:gd name="connsiteY11" fmla="*/ 48638 h 418820"/>
                    <a:gd name="connsiteX12" fmla="*/ 157191 w 534527"/>
                    <a:gd name="connsiteY12" fmla="*/ 38911 h 418820"/>
                    <a:gd name="connsiteX13" fmla="*/ 264195 w 534527"/>
                    <a:gd name="connsiteY13" fmla="*/ 19455 h 418820"/>
                    <a:gd name="connsiteX14" fmla="*/ 342017 w 534527"/>
                    <a:gd name="connsiteY14" fmla="*/ 0 h 418820"/>
                    <a:gd name="connsiteX15" fmla="*/ 371200 w 534527"/>
                    <a:gd name="connsiteY15" fmla="*/ 9728 h 418820"/>
                    <a:gd name="connsiteX16" fmla="*/ 380927 w 534527"/>
                    <a:gd name="connsiteY16" fmla="*/ 48638 h 418820"/>
                    <a:gd name="connsiteX17" fmla="*/ 390655 w 534527"/>
                    <a:gd name="connsiteY17" fmla="*/ 77821 h 418820"/>
                    <a:gd name="connsiteX18" fmla="*/ 429565 w 534527"/>
                    <a:gd name="connsiteY18" fmla="*/ 136187 h 418820"/>
                    <a:gd name="connsiteX19" fmla="*/ 449021 w 534527"/>
                    <a:gd name="connsiteY19" fmla="*/ 165370 h 418820"/>
                    <a:gd name="connsiteX20" fmla="*/ 458748 w 534527"/>
                    <a:gd name="connsiteY20" fmla="*/ 194553 h 418820"/>
                    <a:gd name="connsiteX21" fmla="*/ 478204 w 534527"/>
                    <a:gd name="connsiteY21" fmla="*/ 223736 h 418820"/>
                    <a:gd name="connsiteX22" fmla="*/ 507387 w 534527"/>
                    <a:gd name="connsiteY22" fmla="*/ 291830 h 418820"/>
                    <a:gd name="connsiteX23" fmla="*/ 526842 w 534527"/>
                    <a:gd name="connsiteY23" fmla="*/ 350196 h 418820"/>
                    <a:gd name="connsiteX24" fmla="*/ 526842 w 534527"/>
                    <a:gd name="connsiteY24" fmla="*/ 418289 h 41882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</a:cxnLst>
                  <a:rect l="l" t="t" r="r" b="b"/>
                  <a:pathLst>
                    <a:path w="534527" h="418820">
                      <a:moveTo>
                        <a:pt x="526842" y="418289"/>
                      </a:moveTo>
                      <a:cubicBezTo>
                        <a:pt x="517114" y="423153"/>
                        <a:pt x="487182" y="393408"/>
                        <a:pt x="468476" y="379379"/>
                      </a:cubicBezTo>
                      <a:cubicBezTo>
                        <a:pt x="461139" y="373876"/>
                        <a:pt x="457536" y="363329"/>
                        <a:pt x="449021" y="359923"/>
                      </a:cubicBezTo>
                      <a:cubicBezTo>
                        <a:pt x="405015" y="342320"/>
                        <a:pt x="349599" y="337893"/>
                        <a:pt x="303106" y="330740"/>
                      </a:cubicBezTo>
                      <a:cubicBezTo>
                        <a:pt x="283612" y="327741"/>
                        <a:pt x="264195" y="324255"/>
                        <a:pt x="244740" y="321013"/>
                      </a:cubicBezTo>
                      <a:cubicBezTo>
                        <a:pt x="159867" y="326671"/>
                        <a:pt x="120325" y="322933"/>
                        <a:pt x="50187" y="340468"/>
                      </a:cubicBezTo>
                      <a:cubicBezTo>
                        <a:pt x="40239" y="342955"/>
                        <a:pt x="30732" y="346953"/>
                        <a:pt x="21004" y="350196"/>
                      </a:cubicBezTo>
                      <a:cubicBezTo>
                        <a:pt x="14519" y="356681"/>
                        <a:pt x="5650" y="377854"/>
                        <a:pt x="1548" y="369651"/>
                      </a:cubicBezTo>
                      <a:cubicBezTo>
                        <a:pt x="-4431" y="357693"/>
                        <a:pt x="8654" y="343850"/>
                        <a:pt x="11276" y="330740"/>
                      </a:cubicBezTo>
                      <a:cubicBezTo>
                        <a:pt x="18028" y="296982"/>
                        <a:pt x="26057" y="237003"/>
                        <a:pt x="30731" y="204281"/>
                      </a:cubicBezTo>
                      <a:cubicBezTo>
                        <a:pt x="27489" y="149158"/>
                        <a:pt x="4533" y="91616"/>
                        <a:pt x="21004" y="38911"/>
                      </a:cubicBezTo>
                      <a:cubicBezTo>
                        <a:pt x="26887" y="20085"/>
                        <a:pt x="59646" y="48638"/>
                        <a:pt x="79370" y="48638"/>
                      </a:cubicBezTo>
                      <a:cubicBezTo>
                        <a:pt x="105512" y="48638"/>
                        <a:pt x="131278" y="42366"/>
                        <a:pt x="157191" y="38911"/>
                      </a:cubicBezTo>
                      <a:cubicBezTo>
                        <a:pt x="262595" y="24857"/>
                        <a:pt x="189003" y="36164"/>
                        <a:pt x="264195" y="19455"/>
                      </a:cubicBezTo>
                      <a:cubicBezTo>
                        <a:pt x="334633" y="3802"/>
                        <a:pt x="289865" y="17384"/>
                        <a:pt x="342017" y="0"/>
                      </a:cubicBezTo>
                      <a:cubicBezTo>
                        <a:pt x="351745" y="3243"/>
                        <a:pt x="364794" y="1721"/>
                        <a:pt x="371200" y="9728"/>
                      </a:cubicBezTo>
                      <a:cubicBezTo>
                        <a:pt x="379552" y="20168"/>
                        <a:pt x="377254" y="35783"/>
                        <a:pt x="380927" y="48638"/>
                      </a:cubicBezTo>
                      <a:cubicBezTo>
                        <a:pt x="383744" y="58497"/>
                        <a:pt x="385675" y="68857"/>
                        <a:pt x="390655" y="77821"/>
                      </a:cubicBezTo>
                      <a:cubicBezTo>
                        <a:pt x="402010" y="98261"/>
                        <a:pt x="416595" y="116732"/>
                        <a:pt x="429565" y="136187"/>
                      </a:cubicBezTo>
                      <a:lnTo>
                        <a:pt x="449021" y="165370"/>
                      </a:lnTo>
                      <a:cubicBezTo>
                        <a:pt x="452263" y="175098"/>
                        <a:pt x="454162" y="185382"/>
                        <a:pt x="458748" y="194553"/>
                      </a:cubicBezTo>
                      <a:cubicBezTo>
                        <a:pt x="463977" y="205010"/>
                        <a:pt x="473599" y="212990"/>
                        <a:pt x="478204" y="223736"/>
                      </a:cubicBezTo>
                      <a:cubicBezTo>
                        <a:pt x="515894" y="311679"/>
                        <a:pt x="458541" y="218564"/>
                        <a:pt x="507387" y="291830"/>
                      </a:cubicBezTo>
                      <a:lnTo>
                        <a:pt x="526842" y="350196"/>
                      </a:lnTo>
                      <a:cubicBezTo>
                        <a:pt x="537595" y="382456"/>
                        <a:pt x="536570" y="413425"/>
                        <a:pt x="526842" y="418289"/>
                      </a:cubicBezTo>
                      <a:close/>
                    </a:path>
                  </a:pathLst>
                </a:custGeom>
                <a:noFill/>
                <a:ln w="28575">
                  <a:solidFill>
                    <a:srgbClr val="FF0000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5136323" y="2725995"/>
                  <a:ext cx="185818" cy="22189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>
                      <a:solidFill>
                        <a:srgbClr val="FFFF00"/>
                      </a:solidFill>
                    </a:rPr>
                    <a:t>T</a:t>
                  </a:r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4969809" y="2283064"/>
                  <a:ext cx="259423" cy="22189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>
                      <a:solidFill>
                        <a:srgbClr val="FF0000"/>
                      </a:solidFill>
                    </a:rPr>
                    <a:t>PT</a:t>
                  </a:r>
                </a:p>
              </p:txBody>
            </p:sp>
            <p:sp>
              <p:nvSpPr>
                <p:cNvPr id="23" name="Freeform 22"/>
                <p:cNvSpPr/>
                <p:nvPr/>
              </p:nvSpPr>
              <p:spPr>
                <a:xfrm>
                  <a:off x="4888676" y="2526456"/>
                  <a:ext cx="771525" cy="676275"/>
                </a:xfrm>
                <a:custGeom>
                  <a:avLst/>
                  <a:gdLst>
                    <a:gd name="connsiteX0" fmla="*/ 76200 w 771525"/>
                    <a:gd name="connsiteY0" fmla="*/ 85725 h 676275"/>
                    <a:gd name="connsiteX1" fmla="*/ 28575 w 771525"/>
                    <a:gd name="connsiteY1" fmla="*/ 104775 h 676275"/>
                    <a:gd name="connsiteX2" fmla="*/ 9525 w 771525"/>
                    <a:gd name="connsiteY2" fmla="*/ 161925 h 676275"/>
                    <a:gd name="connsiteX3" fmla="*/ 0 w 771525"/>
                    <a:gd name="connsiteY3" fmla="*/ 190500 h 676275"/>
                    <a:gd name="connsiteX4" fmla="*/ 19050 w 771525"/>
                    <a:gd name="connsiteY4" fmla="*/ 304800 h 676275"/>
                    <a:gd name="connsiteX5" fmla="*/ 38100 w 771525"/>
                    <a:gd name="connsiteY5" fmla="*/ 333375 h 676275"/>
                    <a:gd name="connsiteX6" fmla="*/ 66675 w 771525"/>
                    <a:gd name="connsiteY6" fmla="*/ 361950 h 676275"/>
                    <a:gd name="connsiteX7" fmla="*/ 171450 w 771525"/>
                    <a:gd name="connsiteY7" fmla="*/ 381000 h 676275"/>
                    <a:gd name="connsiteX8" fmla="*/ 200025 w 771525"/>
                    <a:gd name="connsiteY8" fmla="*/ 390525 h 676275"/>
                    <a:gd name="connsiteX9" fmla="*/ 190500 w 771525"/>
                    <a:gd name="connsiteY9" fmla="*/ 419100 h 676275"/>
                    <a:gd name="connsiteX10" fmla="*/ 209550 w 771525"/>
                    <a:gd name="connsiteY10" fmla="*/ 476250 h 676275"/>
                    <a:gd name="connsiteX11" fmla="*/ 238125 w 771525"/>
                    <a:gd name="connsiteY11" fmla="*/ 533400 h 676275"/>
                    <a:gd name="connsiteX12" fmla="*/ 333375 w 771525"/>
                    <a:gd name="connsiteY12" fmla="*/ 552450 h 676275"/>
                    <a:gd name="connsiteX13" fmla="*/ 342900 w 771525"/>
                    <a:gd name="connsiteY13" fmla="*/ 581025 h 676275"/>
                    <a:gd name="connsiteX14" fmla="*/ 409575 w 771525"/>
                    <a:gd name="connsiteY14" fmla="*/ 600075 h 676275"/>
                    <a:gd name="connsiteX15" fmla="*/ 466725 w 771525"/>
                    <a:gd name="connsiteY15" fmla="*/ 628650 h 676275"/>
                    <a:gd name="connsiteX16" fmla="*/ 495300 w 771525"/>
                    <a:gd name="connsiteY16" fmla="*/ 647700 h 676275"/>
                    <a:gd name="connsiteX17" fmla="*/ 552450 w 771525"/>
                    <a:gd name="connsiteY17" fmla="*/ 666750 h 676275"/>
                    <a:gd name="connsiteX18" fmla="*/ 581025 w 771525"/>
                    <a:gd name="connsiteY18" fmla="*/ 676275 h 676275"/>
                    <a:gd name="connsiteX19" fmla="*/ 676275 w 771525"/>
                    <a:gd name="connsiteY19" fmla="*/ 657225 h 676275"/>
                    <a:gd name="connsiteX20" fmla="*/ 762000 w 771525"/>
                    <a:gd name="connsiteY20" fmla="*/ 590550 h 676275"/>
                    <a:gd name="connsiteX21" fmla="*/ 771525 w 771525"/>
                    <a:gd name="connsiteY21" fmla="*/ 561975 h 676275"/>
                    <a:gd name="connsiteX22" fmla="*/ 752475 w 771525"/>
                    <a:gd name="connsiteY22" fmla="*/ 476250 h 676275"/>
                    <a:gd name="connsiteX23" fmla="*/ 733425 w 771525"/>
                    <a:gd name="connsiteY23" fmla="*/ 447675 h 676275"/>
                    <a:gd name="connsiteX24" fmla="*/ 714375 w 771525"/>
                    <a:gd name="connsiteY24" fmla="*/ 409575 h 676275"/>
                    <a:gd name="connsiteX25" fmla="*/ 714375 w 771525"/>
                    <a:gd name="connsiteY25" fmla="*/ 247650 h 676275"/>
                    <a:gd name="connsiteX26" fmla="*/ 666750 w 771525"/>
                    <a:gd name="connsiteY26" fmla="*/ 161925 h 676275"/>
                    <a:gd name="connsiteX27" fmla="*/ 638175 w 771525"/>
                    <a:gd name="connsiteY27" fmla="*/ 152400 h 676275"/>
                    <a:gd name="connsiteX28" fmla="*/ 571500 w 771525"/>
                    <a:gd name="connsiteY28" fmla="*/ 114300 h 676275"/>
                    <a:gd name="connsiteX29" fmla="*/ 495300 w 771525"/>
                    <a:gd name="connsiteY29" fmla="*/ 104775 h 676275"/>
                    <a:gd name="connsiteX30" fmla="*/ 438150 w 771525"/>
                    <a:gd name="connsiteY30" fmla="*/ 85725 h 676275"/>
                    <a:gd name="connsiteX31" fmla="*/ 409575 w 771525"/>
                    <a:gd name="connsiteY31" fmla="*/ 57150 h 676275"/>
                    <a:gd name="connsiteX32" fmla="*/ 352425 w 771525"/>
                    <a:gd name="connsiteY32" fmla="*/ 38100 h 676275"/>
                    <a:gd name="connsiteX33" fmla="*/ 314325 w 771525"/>
                    <a:gd name="connsiteY33" fmla="*/ 19050 h 676275"/>
                    <a:gd name="connsiteX34" fmla="*/ 238125 w 771525"/>
                    <a:gd name="connsiteY34" fmla="*/ 0 h 676275"/>
                    <a:gd name="connsiteX35" fmla="*/ 114300 w 771525"/>
                    <a:gd name="connsiteY35" fmla="*/ 19050 h 676275"/>
                    <a:gd name="connsiteX36" fmla="*/ 85725 w 771525"/>
                    <a:gd name="connsiteY36" fmla="*/ 38100 h 676275"/>
                    <a:gd name="connsiteX37" fmla="*/ 66675 w 771525"/>
                    <a:gd name="connsiteY37" fmla="*/ 66675 h 676275"/>
                    <a:gd name="connsiteX38" fmla="*/ 76200 w 771525"/>
                    <a:gd name="connsiteY38" fmla="*/ 85725 h 67627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</a:cxnLst>
                  <a:rect l="l" t="t" r="r" b="b"/>
                  <a:pathLst>
                    <a:path w="771525" h="676275">
                      <a:moveTo>
                        <a:pt x="76200" y="85725"/>
                      </a:moveTo>
                      <a:cubicBezTo>
                        <a:pt x="69850" y="92075"/>
                        <a:pt x="39834" y="91908"/>
                        <a:pt x="28575" y="104775"/>
                      </a:cubicBezTo>
                      <a:cubicBezTo>
                        <a:pt x="15352" y="119887"/>
                        <a:pt x="15875" y="142875"/>
                        <a:pt x="9525" y="161925"/>
                      </a:cubicBezTo>
                      <a:lnTo>
                        <a:pt x="0" y="190500"/>
                      </a:lnTo>
                      <a:cubicBezTo>
                        <a:pt x="3018" y="217662"/>
                        <a:pt x="3093" y="272885"/>
                        <a:pt x="19050" y="304800"/>
                      </a:cubicBezTo>
                      <a:cubicBezTo>
                        <a:pt x="24170" y="315039"/>
                        <a:pt x="30771" y="324581"/>
                        <a:pt x="38100" y="333375"/>
                      </a:cubicBezTo>
                      <a:cubicBezTo>
                        <a:pt x="46724" y="343723"/>
                        <a:pt x="54979" y="355267"/>
                        <a:pt x="66675" y="361950"/>
                      </a:cubicBezTo>
                      <a:cubicBezTo>
                        <a:pt x="81645" y="370504"/>
                        <a:pt x="168836" y="380627"/>
                        <a:pt x="171450" y="381000"/>
                      </a:cubicBezTo>
                      <a:cubicBezTo>
                        <a:pt x="180975" y="384175"/>
                        <a:pt x="195535" y="381545"/>
                        <a:pt x="200025" y="390525"/>
                      </a:cubicBezTo>
                      <a:cubicBezTo>
                        <a:pt x="204515" y="399505"/>
                        <a:pt x="189391" y="409121"/>
                        <a:pt x="190500" y="419100"/>
                      </a:cubicBezTo>
                      <a:cubicBezTo>
                        <a:pt x="192718" y="439058"/>
                        <a:pt x="203200" y="457200"/>
                        <a:pt x="209550" y="476250"/>
                      </a:cubicBezTo>
                      <a:cubicBezTo>
                        <a:pt x="214983" y="492550"/>
                        <a:pt x="222298" y="522849"/>
                        <a:pt x="238125" y="533400"/>
                      </a:cubicBezTo>
                      <a:cubicBezTo>
                        <a:pt x="247598" y="539715"/>
                        <a:pt x="333187" y="552419"/>
                        <a:pt x="333375" y="552450"/>
                      </a:cubicBezTo>
                      <a:cubicBezTo>
                        <a:pt x="336550" y="561975"/>
                        <a:pt x="335800" y="573925"/>
                        <a:pt x="342900" y="581025"/>
                      </a:cubicBezTo>
                      <a:cubicBezTo>
                        <a:pt x="347455" y="585580"/>
                        <a:pt x="409245" y="599993"/>
                        <a:pt x="409575" y="600075"/>
                      </a:cubicBezTo>
                      <a:cubicBezTo>
                        <a:pt x="491467" y="654670"/>
                        <a:pt x="387855" y="589215"/>
                        <a:pt x="466725" y="628650"/>
                      </a:cubicBezTo>
                      <a:cubicBezTo>
                        <a:pt x="476964" y="633770"/>
                        <a:pt x="484839" y="643051"/>
                        <a:pt x="495300" y="647700"/>
                      </a:cubicBezTo>
                      <a:cubicBezTo>
                        <a:pt x="513650" y="655855"/>
                        <a:pt x="533400" y="660400"/>
                        <a:pt x="552450" y="666750"/>
                      </a:cubicBezTo>
                      <a:lnTo>
                        <a:pt x="581025" y="676275"/>
                      </a:lnTo>
                      <a:cubicBezTo>
                        <a:pt x="588201" y="675079"/>
                        <a:pt x="662066" y="664330"/>
                        <a:pt x="676275" y="657225"/>
                      </a:cubicBezTo>
                      <a:cubicBezTo>
                        <a:pt x="721847" y="634439"/>
                        <a:pt x="730642" y="621908"/>
                        <a:pt x="762000" y="590550"/>
                      </a:cubicBezTo>
                      <a:cubicBezTo>
                        <a:pt x="765175" y="581025"/>
                        <a:pt x="771525" y="572015"/>
                        <a:pt x="771525" y="561975"/>
                      </a:cubicBezTo>
                      <a:cubicBezTo>
                        <a:pt x="771525" y="547342"/>
                        <a:pt x="762297" y="495895"/>
                        <a:pt x="752475" y="476250"/>
                      </a:cubicBezTo>
                      <a:cubicBezTo>
                        <a:pt x="747355" y="466011"/>
                        <a:pt x="739105" y="457614"/>
                        <a:pt x="733425" y="447675"/>
                      </a:cubicBezTo>
                      <a:cubicBezTo>
                        <a:pt x="726380" y="435347"/>
                        <a:pt x="720725" y="422275"/>
                        <a:pt x="714375" y="409575"/>
                      </a:cubicBezTo>
                      <a:cubicBezTo>
                        <a:pt x="736242" y="343974"/>
                        <a:pt x="732384" y="367709"/>
                        <a:pt x="714375" y="247650"/>
                      </a:cubicBezTo>
                      <a:cubicBezTo>
                        <a:pt x="708853" y="210834"/>
                        <a:pt x="697592" y="182486"/>
                        <a:pt x="666750" y="161925"/>
                      </a:cubicBezTo>
                      <a:cubicBezTo>
                        <a:pt x="658396" y="156356"/>
                        <a:pt x="647155" y="156890"/>
                        <a:pt x="638175" y="152400"/>
                      </a:cubicBezTo>
                      <a:cubicBezTo>
                        <a:pt x="609832" y="138228"/>
                        <a:pt x="604898" y="122649"/>
                        <a:pt x="571500" y="114300"/>
                      </a:cubicBezTo>
                      <a:cubicBezTo>
                        <a:pt x="546667" y="108092"/>
                        <a:pt x="520700" y="107950"/>
                        <a:pt x="495300" y="104775"/>
                      </a:cubicBezTo>
                      <a:cubicBezTo>
                        <a:pt x="476250" y="98425"/>
                        <a:pt x="452349" y="99924"/>
                        <a:pt x="438150" y="85725"/>
                      </a:cubicBezTo>
                      <a:cubicBezTo>
                        <a:pt x="428625" y="76200"/>
                        <a:pt x="421350" y="63692"/>
                        <a:pt x="409575" y="57150"/>
                      </a:cubicBezTo>
                      <a:cubicBezTo>
                        <a:pt x="392022" y="47398"/>
                        <a:pt x="370386" y="47080"/>
                        <a:pt x="352425" y="38100"/>
                      </a:cubicBezTo>
                      <a:cubicBezTo>
                        <a:pt x="339725" y="31750"/>
                        <a:pt x="327376" y="24643"/>
                        <a:pt x="314325" y="19050"/>
                      </a:cubicBezTo>
                      <a:cubicBezTo>
                        <a:pt x="288697" y="8067"/>
                        <a:pt x="266078" y="5591"/>
                        <a:pt x="238125" y="0"/>
                      </a:cubicBezTo>
                      <a:cubicBezTo>
                        <a:pt x="232988" y="734"/>
                        <a:pt x="124212" y="15746"/>
                        <a:pt x="114300" y="19050"/>
                      </a:cubicBezTo>
                      <a:cubicBezTo>
                        <a:pt x="103440" y="22670"/>
                        <a:pt x="95250" y="31750"/>
                        <a:pt x="85725" y="38100"/>
                      </a:cubicBezTo>
                      <a:cubicBezTo>
                        <a:pt x="79375" y="47625"/>
                        <a:pt x="71795" y="56436"/>
                        <a:pt x="66675" y="66675"/>
                      </a:cubicBezTo>
                      <a:cubicBezTo>
                        <a:pt x="62185" y="75655"/>
                        <a:pt x="82550" y="79375"/>
                        <a:pt x="76200" y="85725"/>
                      </a:cubicBezTo>
                      <a:close/>
                    </a:path>
                  </a:pathLst>
                </a:custGeom>
                <a:noFill/>
                <a:ln w="28575">
                  <a:solidFill>
                    <a:srgbClr val="FFFF00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sp>
            <p:nvSpPr>
              <p:cNvPr id="5" name="TextBox 4"/>
              <p:cNvSpPr txBox="1"/>
              <p:nvPr/>
            </p:nvSpPr>
            <p:spPr>
              <a:xfrm>
                <a:off x="4772641" y="2670847"/>
                <a:ext cx="2968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solidFill>
                      <a:srgbClr val="FFFF00"/>
                    </a:solidFill>
                  </a:rPr>
                  <a:t>T</a:t>
                </a: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2558368" y="1223433"/>
                <a:ext cx="32412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A</a:t>
                </a: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5322512" y="1189566"/>
                <a:ext cx="32412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B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7005649" y="1202939"/>
                <a:ext cx="18473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en-US" b="1" dirty="0"/>
              </a:p>
            </p:txBody>
          </p:sp>
        </p:grp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DD452E07-4B90-E249-AD9E-553707B0BDD8}"/>
                </a:ext>
              </a:extLst>
            </p:cNvPr>
            <p:cNvSpPr txBox="1"/>
            <p:nvPr/>
          </p:nvSpPr>
          <p:spPr>
            <a:xfrm>
              <a:off x="229808" y="3851309"/>
              <a:ext cx="4615147" cy="17543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1.  Collection of tissue samples for </a:t>
              </a:r>
              <a:r>
                <a:rPr lang="en-US" dirty="0" err="1">
                  <a:latin typeface="Arial" panose="020B0604020202020204" pitchFamily="34" charset="0"/>
                  <a:cs typeface="Arial" panose="020B0604020202020204" pitchFamily="34" charset="0"/>
                </a:rPr>
                <a:t>biodistribution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 studies.  (A) Normal tissue collected on the opposite of the tumor-bearing lobe. (B) </a:t>
              </a:r>
              <a:r>
                <a:rPr lang="en-US" dirty="0" err="1">
                  <a:latin typeface="Arial" panose="020B0604020202020204" pitchFamily="34" charset="0"/>
                  <a:cs typeface="Arial" panose="020B0604020202020204" pitchFamily="34" charset="0"/>
                </a:rPr>
                <a:t>Peritumoral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 (PT) area is the area adjacent to the tumor (T).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8525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61D16999AEA684AA541E392A7F55792" ma:contentTypeVersion="9" ma:contentTypeDescription="Create a new document." ma:contentTypeScope="" ma:versionID="c80c5f2d25238de582c325549e5e3055">
  <xsd:schema xmlns:xsd="http://www.w3.org/2001/XMLSchema" xmlns:xs="http://www.w3.org/2001/XMLSchema" xmlns:p="http://schemas.microsoft.com/office/2006/metadata/properties" xmlns:ns2="19792d4c-5389-4535-8c71-687c71fb9baa" targetNamespace="http://schemas.microsoft.com/office/2006/metadata/properties" ma:root="true" ma:fieldsID="82a5c04059668e6c4e3e30815ffb1d41" ns2:_="">
    <xsd:import namespace="19792d4c-5389-4535-8c71-687c71fb9ba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792d4c-5389-4535-8c71-687c71fb9ba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D758ABEF-D199-4FF7-974F-3F437114983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9792d4c-5389-4535-8c71-687c71fb9ba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AD337343-A152-47B6-8AE6-5902766F711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432A6B2-A59A-49C0-800D-ED9F1BC5AB79}">
  <ds:schemaRefs>
    <ds:schemaRef ds:uri="http://schemas.microsoft.com/office/2006/documentManagement/types"/>
    <ds:schemaRef ds:uri="http://www.w3.org/XML/1998/namespace"/>
    <ds:schemaRef ds:uri="http://schemas.microsoft.com/office/2006/metadata/properties"/>
    <ds:schemaRef ds:uri="http://schemas.microsoft.com/office/infopath/2007/PartnerControls"/>
    <ds:schemaRef ds:uri="http://purl.org/dc/dcmitype/"/>
    <ds:schemaRef ds:uri="http://purl.org/dc/terms/"/>
    <ds:schemaRef ds:uri="http://purl.org/dc/elements/1.1/"/>
    <ds:schemaRef ds:uri="http://schemas.openxmlformats.org/package/2006/metadata/core-properties"/>
    <ds:schemaRef ds:uri="19792d4c-5389-4535-8c71-687c71fb9ba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490</TotalTime>
  <Words>50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elancon,Marites P</cp:lastModifiedBy>
  <cp:revision>142</cp:revision>
  <cp:lastPrinted>2019-10-30T19:43:42Z</cp:lastPrinted>
  <dcterms:created xsi:type="dcterms:W3CDTF">2019-05-31T12:52:46Z</dcterms:created>
  <dcterms:modified xsi:type="dcterms:W3CDTF">2021-01-11T14:23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61D16999AEA684AA541E392A7F55792</vt:lpwstr>
  </property>
</Properties>
</file>